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81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99"/>
    <a:srgbClr val="FF00FF"/>
    <a:srgbClr val="FF6FC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272" autoAdjust="0"/>
  </p:normalViewPr>
  <p:slideViewPr>
    <p:cSldViewPr>
      <p:cViewPr varScale="1">
        <p:scale>
          <a:sx n="93" d="100"/>
          <a:sy n="93" d="100"/>
        </p:scale>
        <p:origin x="-30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9526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EFEEEDB9-6F83-4625-BAEB-1A36272C65BA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9526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B13C08F8-9E65-4AB3-B674-D298DF1CBEC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4418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-6368" y="2760"/>
            <a:ext cx="1800200" cy="634082"/>
          </a:xfrm>
        </p:spPr>
        <p:txBody>
          <a:bodyPr>
            <a:normAutofit fontScale="90000"/>
          </a:bodyPr>
          <a:lstStyle/>
          <a:p>
            <a:pPr algn="l"/>
            <a:r>
              <a:rPr kumimoji="1" lang="en-US" altLang="ja-JP" sz="1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dditional file 4</a:t>
            </a:r>
            <a:br>
              <a:rPr kumimoji="1" lang="en-US" altLang="ja-JP" sz="1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</a:br>
            <a:r>
              <a:rPr kumimoji="1" lang="en-US" altLang="ja-JP" sz="1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3</a:t>
            </a:r>
            <a:endParaRPr kumimoji="1" lang="ja-JP" altLang="en-US" sz="1800" i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334963" y="2057400"/>
          <a:ext cx="8474075" cy="2743200"/>
        </p:xfrm>
        <a:graphic>
          <a:graphicData uri="http://schemas.openxmlformats.org/presentationml/2006/ole">
            <p:oleObj spid="_x0000_s39945" name="CS ChemDraw Drawing" r:id="rId3" imgW="8473017" imgH="2745317" progId="">
              <p:embed/>
            </p:oleObj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179512" y="5373216"/>
            <a:ext cx="86409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ea typeface="Arial Unicode MS" pitchFamily="50" charset="-128"/>
                <a:cs typeface="Times New Roman" pitchFamily="18" charset="0"/>
              </a:rPr>
              <a:t>Figure S3.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Predicted chemical structure of the product from PKS-I/NRPS hybrid gene cluster  #20 (Table 2) in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otitidiscaviarum.</a:t>
            </a:r>
            <a:endParaRPr lang="ja-JP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68</TotalTime>
  <Words>28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Office テーマ</vt:lpstr>
      <vt:lpstr>CS ChemDraw Drawing</vt:lpstr>
      <vt:lpstr>Additional file 4 Figure S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gonoi</dc:creator>
  <cp:lastModifiedBy>gonoi_2</cp:lastModifiedBy>
  <cp:revision>145</cp:revision>
  <dcterms:created xsi:type="dcterms:W3CDTF">2013-05-22T01:19:02Z</dcterms:created>
  <dcterms:modified xsi:type="dcterms:W3CDTF">2014-04-11T23:19:06Z</dcterms:modified>
</cp:coreProperties>
</file>